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7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/>
    <p:restoredTop sz="93164"/>
  </p:normalViewPr>
  <p:slideViewPr>
    <p:cSldViewPr snapToGrid="0" snapToObjects="1">
      <p:cViewPr varScale="1">
        <p:scale>
          <a:sx n="114" d="100"/>
          <a:sy n="114" d="100"/>
        </p:scale>
        <p:origin x="16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4BDC1D-DB98-0C4C-A534-ADCF2A624A6D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900363" y="857250"/>
            <a:ext cx="3343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8464A0-83D1-4948-8F92-7AC0C08E27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9000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198FA-EB48-A84E-9BE2-0B7F078B61B9}" type="datetimeFigureOut">
              <a:rPr lang="en-US" smtClean="0"/>
              <a:t>10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CE40B-F915-E34C-976A-E9D79A2158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97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6728689" cy="5138163"/>
            <a:chOff x="3841775" y="409197"/>
            <a:chExt cx="6728689" cy="513816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567060" y="3941147"/>
              <a:ext cx="4003404" cy="1606213"/>
            </a:xfrm>
            <a:prstGeom prst="rect">
              <a:avLst/>
            </a:prstGeom>
          </p:spPr>
        </p:pic>
        <p:grpSp>
          <p:nvGrpSpPr>
            <p:cNvPr id="6" name="Group 5"/>
            <p:cNvGrpSpPr/>
            <p:nvPr/>
          </p:nvGrpSpPr>
          <p:grpSpPr>
            <a:xfrm>
              <a:off x="3841775" y="409197"/>
              <a:ext cx="6728689" cy="5138163"/>
              <a:chOff x="3841775" y="409197"/>
              <a:chExt cx="6728689" cy="5138163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3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75633" y="449161"/>
                <a:ext cx="6694831" cy="3452022"/>
              </a:xfrm>
              <a:prstGeom prst="rect">
                <a:avLst/>
              </a:prstGeom>
            </p:spPr>
          </p:pic>
          <p:grpSp>
            <p:nvGrpSpPr>
              <p:cNvPr id="8" name="Group 7"/>
              <p:cNvGrpSpPr/>
              <p:nvPr/>
            </p:nvGrpSpPr>
            <p:grpSpPr>
              <a:xfrm>
                <a:off x="3841775" y="409197"/>
                <a:ext cx="3002040" cy="5138163"/>
                <a:chOff x="3768623" y="433581"/>
                <a:chExt cx="3002040" cy="5138163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 rotWithShape="1">
                <a:blip r:embed="rId4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5634846" y="3965531"/>
                  <a:ext cx="790051" cy="1606213"/>
                </a:xfrm>
                <a:prstGeom prst="rect">
                  <a:avLst/>
                </a:prstGeom>
              </p:spPr>
            </p:pic>
            <p:grpSp>
              <p:nvGrpSpPr>
                <p:cNvPr id="10" name="Group 9"/>
                <p:cNvGrpSpPr/>
                <p:nvPr/>
              </p:nvGrpSpPr>
              <p:grpSpPr>
                <a:xfrm>
                  <a:off x="3768623" y="433581"/>
                  <a:ext cx="3002040" cy="5138163"/>
                  <a:chOff x="3768623" y="433581"/>
                  <a:chExt cx="3002040" cy="5138163"/>
                </a:xfrm>
              </p:grpSpPr>
              <p:pic>
                <p:nvPicPr>
                  <p:cNvPr id="11" name="Picture 10"/>
                  <p:cNvPicPr>
                    <a:picLocks noChangeAspect="1"/>
                  </p:cNvPicPr>
                  <p:nvPr/>
                </p:nvPicPr>
                <p:blipFill rotWithShape="1">
                  <a:blip r:embed="rId5" cstate="email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/>
                </p:blipFill>
                <p:spPr>
                  <a:xfrm>
                    <a:off x="3802481" y="3965531"/>
                    <a:ext cx="1763354" cy="1606213"/>
                  </a:xfrm>
                  <a:prstGeom prst="rect">
                    <a:avLst/>
                  </a:prstGeom>
                </p:spPr>
              </p:pic>
              <p:grpSp>
                <p:nvGrpSpPr>
                  <p:cNvPr id="12" name="Group 11"/>
                  <p:cNvGrpSpPr/>
                  <p:nvPr/>
                </p:nvGrpSpPr>
                <p:grpSpPr>
                  <a:xfrm>
                    <a:off x="3768623" y="3885602"/>
                    <a:ext cx="3002040" cy="393443"/>
                    <a:chOff x="3768623" y="3885602"/>
                    <a:chExt cx="3002040" cy="393443"/>
                  </a:xfrm>
                </p:grpSpPr>
                <p:grpSp>
                  <p:nvGrpSpPr>
                    <p:cNvPr id="14" name="Group 13"/>
                    <p:cNvGrpSpPr/>
                    <p:nvPr/>
                  </p:nvGrpSpPr>
                  <p:grpSpPr>
                    <a:xfrm>
                      <a:off x="3768623" y="3885602"/>
                      <a:ext cx="2073033" cy="393443"/>
                      <a:chOff x="3768623" y="3885602"/>
                      <a:chExt cx="2073033" cy="393443"/>
                    </a:xfrm>
                  </p:grpSpPr>
                  <p:sp>
                    <p:nvSpPr>
                      <p:cNvPr id="16" name="TextBox 15"/>
                      <p:cNvSpPr txBox="1"/>
                      <p:nvPr/>
                    </p:nvSpPr>
                    <p:spPr>
                      <a:xfrm>
                        <a:off x="5565835" y="3885602"/>
                        <a:ext cx="275821" cy="39344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dirty="0"/>
                          <a:t>C</a:t>
                        </a:r>
                      </a:p>
                    </p:txBody>
                  </p:sp>
                  <p:sp>
                    <p:nvSpPr>
                      <p:cNvPr id="17" name="TextBox 16"/>
                      <p:cNvSpPr txBox="1"/>
                      <p:nvPr/>
                    </p:nvSpPr>
                    <p:spPr>
                      <a:xfrm>
                        <a:off x="3768623" y="3885602"/>
                        <a:ext cx="756178" cy="3693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dirty="0"/>
                          <a:t>B</a:t>
                        </a:r>
                      </a:p>
                    </p:txBody>
                  </p:sp>
                </p:grpSp>
                <p:sp>
                  <p:nvSpPr>
                    <p:cNvPr id="15" name="TextBox 14"/>
                    <p:cNvSpPr txBox="1"/>
                    <p:nvPr/>
                  </p:nvSpPr>
                  <p:spPr>
                    <a:xfrm>
                      <a:off x="6424897" y="3885602"/>
                      <a:ext cx="345766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dirty="0"/>
                        <a:t>D</a:t>
                      </a:r>
                    </a:p>
                  </p:txBody>
                </p:sp>
              </p:grpSp>
              <p:sp>
                <p:nvSpPr>
                  <p:cNvPr id="13" name="TextBox 12"/>
                  <p:cNvSpPr txBox="1"/>
                  <p:nvPr/>
                </p:nvSpPr>
                <p:spPr>
                  <a:xfrm>
                    <a:off x="3768623" y="433581"/>
                    <a:ext cx="59055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/>
                      <a:t>A</a:t>
                    </a:r>
                  </a:p>
                </p:txBody>
              </p:sp>
            </p:grpSp>
          </p:grpSp>
        </p:grpSp>
      </p:grpSp>
      <p:graphicFrame>
        <p:nvGraphicFramePr>
          <p:cNvPr id="46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65062428"/>
              </p:ext>
            </p:extLst>
          </p:nvPr>
        </p:nvGraphicFramePr>
        <p:xfrm>
          <a:off x="3777539" y="5178127"/>
          <a:ext cx="2951150" cy="1554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81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029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25209">
                <a:tc>
                  <a:txBody>
                    <a:bodyPr/>
                    <a:lstStyle/>
                    <a:p>
                      <a:r>
                        <a:rPr lang="en-US" sz="1100" dirty="0" err="1">
                          <a:solidFill>
                            <a:schemeClr val="tx1"/>
                          </a:solidFill>
                        </a:rPr>
                        <a:t>Colour</a:t>
                      </a:r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Location of slaughter hous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25209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F0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err="1"/>
                        <a:t>Ndumbuini</a:t>
                      </a:r>
                      <a:r>
                        <a:rPr lang="en-US" sz="1100" dirty="0"/>
                        <a:t>, Nairobi, Keny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25209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3F7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err="1"/>
                        <a:t>Busia</a:t>
                      </a:r>
                      <a:r>
                        <a:rPr lang="en-US" sz="1100" dirty="0"/>
                        <a:t>, Keny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5209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40A7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err="1"/>
                        <a:t>Chikwawa</a:t>
                      </a:r>
                      <a:r>
                        <a:rPr lang="en-US" sz="1100" dirty="0"/>
                        <a:t>, Malaw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5209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6C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err="1"/>
                        <a:t>Ngabu</a:t>
                      </a:r>
                      <a:r>
                        <a:rPr lang="en-US" sz="1100" dirty="0"/>
                        <a:t>, Malaw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5209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209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 err="1"/>
                        <a:t>Nchalo</a:t>
                      </a:r>
                      <a:r>
                        <a:rPr lang="en-US" sz="1100" dirty="0"/>
                        <a:t>,</a:t>
                      </a:r>
                      <a:r>
                        <a:rPr lang="en-US" sz="1100" baseline="0" dirty="0"/>
                        <a:t> Malawi</a:t>
                      </a:r>
                      <a:endParaRPr lang="en-US" sz="11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56751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807</TotalTime>
  <Words>26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lford, Caisey</dc:creator>
  <cp:lastModifiedBy>Mike Fisher</cp:lastModifiedBy>
  <cp:revision>44</cp:revision>
  <dcterms:created xsi:type="dcterms:W3CDTF">2019-07-02T09:29:23Z</dcterms:created>
  <dcterms:modified xsi:type="dcterms:W3CDTF">2020-10-13T14:01:32Z</dcterms:modified>
</cp:coreProperties>
</file>